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Nov 11,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24 identifiers, 124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1843529"/>
            <a:ext cx="10911535" cy="4764513"/>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2823258" y="1665465"/>
            <a:ext cx="6545178"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2823258" y="1665465"/>
            <a:ext cx="6545178"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